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3.wmf" ContentType="image/x-wmf"/>
  <Override PartName="/ppt/media/image5.png" ContentType="image/png"/>
  <Override PartName="/ppt/media/image1.png" ContentType="image/png"/>
  <Override PartName="/ppt/media/image9.wmf" ContentType="image/x-wmf"/>
  <Override PartName="/ppt/media/image14.wmf" ContentType="image/x-wmf"/>
  <Override PartName="/ppt/media/image6.png" ContentType="image/png"/>
  <Override PartName="/ppt/media/image10.wmf" ContentType="image/x-wmf"/>
  <Override PartName="/ppt/media/image2.png" ContentType="image/png"/>
  <Override PartName="/ppt/media/image15.wmf" ContentType="image/x-wmf"/>
  <Override PartName="/ppt/media/image7.png" ContentType="image/png"/>
  <Override PartName="/ppt/media/image11.wmf" ContentType="image/x-wmf"/>
  <Override PartName="/ppt/media/image3.png" ContentType="image/png"/>
  <Override PartName="/ppt/media/image8.png" ContentType="image/png"/>
  <Override PartName="/ppt/media/image12.wmf" ContentType="image/x-wmf"/>
  <Override PartName="/ppt/media/image4.png" ContentType="image/png"/>
  <Override PartName="/ppt/embeddings/oleObject1.bin" ContentType="application/vnd.openxmlformats-officedocument.oleObject"/>
  <Override PartName="/ppt/embeddings/oleObject2.bin" ContentType="application/vnd.openxmlformats-officedocument.oleObject"/>
  <Override PartName="/ppt/embeddings/oleObject3.bin" ContentType="application/vnd.openxmlformats-officedocument.oleObject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4.xml.rels" ContentType="application/vnd.openxmlformats-package.relationships+xml"/>
  <Override PartName="/ppt/slides/_rels/slide1.xml.rels" ContentType="application/vnd.openxmlformats-package.relationships+xml"/>
  <Override PartName="/ppt/slides/_rels/slide3.xml.rels" ContentType="application/vnd.openxmlformats-package.relationships+xml"/>
  <Override PartName="/ppt/slides/_rels/slide2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  <p:sldId id="258" r:id="rId5"/>
    <p:sldId id="259" r:id="rId6"/>
  </p:sldIdLst>
  <p:sldSz cx="6858000" cy="9144000"/>
  <p:notesSz cx="6858000" cy="9294813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slide" Target="slides/slide3.xml"/><Relationship Id="rId6" Type="http://schemas.openxmlformats.org/officeDocument/2006/relationships/slide" Target="slides/slide4.xml"/><Relationship Id="rId7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44C1BAE-3522-49BB-81E7-AB4C2C252DE7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71600" y="487440"/>
            <a:ext cx="5914800" cy="1766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71600" y="2433600"/>
            <a:ext cx="591480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71600" y="5464440"/>
            <a:ext cx="591480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F44B57C-6196-4050-8F6A-566BCE14BC0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71600" y="487440"/>
            <a:ext cx="5914800" cy="1766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71600" y="2433600"/>
            <a:ext cx="288612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2440" y="2433600"/>
            <a:ext cx="288612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71600" y="5464440"/>
            <a:ext cx="288612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2440" y="5464440"/>
            <a:ext cx="288612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EC6B6C1-705F-457C-B0AE-B47607B551CC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71600" y="487440"/>
            <a:ext cx="5914800" cy="1766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71600" y="2433600"/>
            <a:ext cx="190440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71760" y="2433600"/>
            <a:ext cx="190440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471560" y="2433600"/>
            <a:ext cx="190440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71600" y="5464440"/>
            <a:ext cx="190440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71760" y="5464440"/>
            <a:ext cx="190440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471560" y="5464440"/>
            <a:ext cx="190440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16C4F2C-A5E4-4E8B-8388-773223185AB6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71600" y="487440"/>
            <a:ext cx="5914800" cy="1766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71600" y="2433600"/>
            <a:ext cx="5914800" cy="58024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0000"/>
              </a:lnSpc>
              <a:spcBef>
                <a:spcPts val="751"/>
              </a:spcBef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3C3DE56-6EA6-4C3E-A229-FAEF28E5E38E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71600" y="487440"/>
            <a:ext cx="5914800" cy="1766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71600" y="2433600"/>
            <a:ext cx="5914800" cy="5802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BF35572-A657-4045-830A-2DA23BAEAEE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71600" y="487440"/>
            <a:ext cx="5914800" cy="1766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71600" y="2433600"/>
            <a:ext cx="2886120" cy="5802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2440" y="2433600"/>
            <a:ext cx="2886120" cy="5802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886C964-DA21-4C02-8CA2-3D9BBF418809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71600" y="487440"/>
            <a:ext cx="5914800" cy="1766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A2EE51B-ED6D-4F66-A430-2A3097C342E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71600" y="487440"/>
            <a:ext cx="5914800" cy="81914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lnSpc>
                <a:spcPct val="90000"/>
              </a:lnSpc>
              <a:spcBef>
                <a:spcPts val="751"/>
              </a:spcBef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3B4F22C-A3C0-4E51-98D5-9E284427CF1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71600" y="487440"/>
            <a:ext cx="5914800" cy="1766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71600" y="2433600"/>
            <a:ext cx="288612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2440" y="2433600"/>
            <a:ext cx="2886120" cy="5802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71600" y="5464440"/>
            <a:ext cx="288612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3ECBA6B-5DCD-480B-9CD9-155671BD695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71600" y="487440"/>
            <a:ext cx="5914800" cy="1766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71600" y="2433600"/>
            <a:ext cx="2886120" cy="5802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2440" y="2433600"/>
            <a:ext cx="288612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2440" y="5464440"/>
            <a:ext cx="288612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7DB8740-D13E-4F70-90D2-8797436C9CA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71600" y="487440"/>
            <a:ext cx="5914800" cy="1766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71600" y="2433600"/>
            <a:ext cx="288612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2440" y="2433600"/>
            <a:ext cx="288612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71600" y="5464440"/>
            <a:ext cx="591480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B2113A9-DB9C-45A6-9F96-E473747FBF3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71600" y="487440"/>
            <a:ext cx="5914800" cy="1766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3300" spc="-1" strike="noStrike">
                <a:solidFill>
                  <a:srgbClr val="000000"/>
                </a:solidFill>
                <a:latin typeface="Calibri Light"/>
              </a:rPr>
              <a:t>Click to edit the title text format</a:t>
            </a: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71600" y="2433600"/>
            <a:ext cx="5914800" cy="5802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17136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  <a:p>
            <a:pPr lvl="1" marL="51444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  <a:p>
            <a:pPr lvl="2" marL="85716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  <a:p>
            <a:pPr lvl="3" marL="120024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  <a:p>
            <a:pPr lvl="4" marL="154296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  <a:p>
            <a:pPr lvl="5" marL="154296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  <a:p>
            <a:pPr lvl="6" marL="154296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71600" y="8475480"/>
            <a:ext cx="154296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900" spc="-1" strike="noStrike">
                <a:solidFill>
                  <a:srgbClr val="898989"/>
                </a:solidFill>
                <a:latin typeface="Calibri"/>
                <a:ea typeface="Gulim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898989"/>
                </a:solidFill>
                <a:latin typeface="Calibri"/>
                <a:ea typeface="Gulim"/>
              </a:rPr>
              <a:t>&lt;date/time&gt;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271600" y="8475480"/>
            <a:ext cx="23148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843440" y="8475480"/>
            <a:ext cx="154296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9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326E251A-3991-4E3D-AD6A-2CAEBC5077F7}" type="slidenum">
              <a:rPr b="0" lang="en-US" sz="9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image" Target="../media/image5.png"/><Relationship Id="rId6" Type="http://schemas.openxmlformats.org/officeDocument/2006/relationships/image" Target="../media/image6.png"/><Relationship Id="rId7" Type="http://schemas.openxmlformats.org/officeDocument/2006/relationships/image" Target="../media/image7.png"/><Relationship Id="rId8" Type="http://schemas.openxmlformats.org/officeDocument/2006/relationships/image" Target="../media/image8.png"/><Relationship Id="rId9" Type="http://schemas.openxmlformats.org/officeDocument/2006/relationships/oleObject" Target="../embeddings/oleObject1.bin"/><Relationship Id="rId10" Type="http://schemas.openxmlformats.org/officeDocument/2006/relationships/image" Target="../media/image9.wmf"/><Relationship Id="rId11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oleObject" Target="../embeddings/oleObject1.bin"/><Relationship Id="rId2" Type="http://schemas.openxmlformats.org/officeDocument/2006/relationships/image" Target="../media/image10.wmf"/><Relationship Id="rId3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oleObject" Target="../embeddings/oleObject1.bin"/><Relationship Id="rId2" Type="http://schemas.openxmlformats.org/officeDocument/2006/relationships/image" Target="../media/image11.wmf"/><Relationship Id="rId3" Type="http://schemas.openxmlformats.org/officeDocument/2006/relationships/oleObject" Target="../embeddings/oleObject2.bin"/><Relationship Id="rId4" Type="http://schemas.openxmlformats.org/officeDocument/2006/relationships/image" Target="../media/image12.wmf"/><Relationship Id="rId5" Type="http://schemas.openxmlformats.org/officeDocument/2006/relationships/slideLayout" Target="../slideLayouts/slideLayout1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oleObject" Target="../embeddings/oleObject1.bin"/><Relationship Id="rId2" Type="http://schemas.openxmlformats.org/officeDocument/2006/relationships/image" Target="../media/image13.wmf"/><Relationship Id="rId3" Type="http://schemas.openxmlformats.org/officeDocument/2006/relationships/oleObject" Target="../embeddings/oleObject2.bin"/><Relationship Id="rId4" Type="http://schemas.openxmlformats.org/officeDocument/2006/relationships/image" Target="../media/image14.wmf"/><Relationship Id="rId5" Type="http://schemas.openxmlformats.org/officeDocument/2006/relationships/oleObject" Target="../embeddings/oleObject3.bin"/><Relationship Id="rId6" Type="http://schemas.openxmlformats.org/officeDocument/2006/relationships/image" Target="../media/image15.wmf"/><Relationship Id="rId7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Group 24"/>
          <p:cNvGrpSpPr/>
          <p:nvPr/>
        </p:nvGrpSpPr>
        <p:grpSpPr>
          <a:xfrm>
            <a:off x="2295360" y="2057400"/>
            <a:ext cx="4467240" cy="2104920"/>
            <a:chOff x="2295360" y="2057400"/>
            <a:chExt cx="4467240" cy="2104920"/>
          </a:xfrm>
        </p:grpSpPr>
        <p:pic>
          <p:nvPicPr>
            <p:cNvPr id="42" name="Picture 6" descr=""/>
            <p:cNvPicPr/>
            <p:nvPr/>
          </p:nvPicPr>
          <p:blipFill>
            <a:blip r:embed="rId1"/>
            <a:stretch/>
          </p:blipFill>
          <p:spPr>
            <a:xfrm>
              <a:off x="3415320" y="3120840"/>
              <a:ext cx="1098720" cy="104148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43" name="Picture 7" descr=""/>
            <p:cNvPicPr/>
            <p:nvPr/>
          </p:nvPicPr>
          <p:blipFill>
            <a:blip r:embed="rId2"/>
            <a:stretch/>
          </p:blipFill>
          <p:spPr>
            <a:xfrm>
              <a:off x="3415320" y="2057400"/>
              <a:ext cx="1098720" cy="104148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44" name="Picture 8" descr=""/>
            <p:cNvPicPr/>
            <p:nvPr/>
          </p:nvPicPr>
          <p:blipFill>
            <a:blip r:embed="rId3"/>
            <a:stretch/>
          </p:blipFill>
          <p:spPr>
            <a:xfrm>
              <a:off x="2295360" y="2057400"/>
              <a:ext cx="1098720" cy="104148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45" name="Picture 9" descr=""/>
            <p:cNvPicPr/>
            <p:nvPr/>
          </p:nvPicPr>
          <p:blipFill>
            <a:blip r:embed="rId4"/>
            <a:stretch/>
          </p:blipFill>
          <p:spPr>
            <a:xfrm>
              <a:off x="2295360" y="3120840"/>
              <a:ext cx="1098720" cy="104148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46" name="Picture 2" descr=""/>
            <p:cNvPicPr/>
            <p:nvPr/>
          </p:nvPicPr>
          <p:blipFill>
            <a:blip r:embed="rId5"/>
            <a:stretch/>
          </p:blipFill>
          <p:spPr>
            <a:xfrm>
              <a:off x="5663880" y="3120840"/>
              <a:ext cx="1098720" cy="104148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47" name="Picture 3" descr=""/>
            <p:cNvPicPr/>
            <p:nvPr/>
          </p:nvPicPr>
          <p:blipFill>
            <a:blip r:embed="rId6"/>
            <a:stretch/>
          </p:blipFill>
          <p:spPr>
            <a:xfrm>
              <a:off x="4542120" y="2058480"/>
              <a:ext cx="1098720" cy="104148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48" name="Picture 4" descr=""/>
            <p:cNvPicPr/>
            <p:nvPr/>
          </p:nvPicPr>
          <p:blipFill>
            <a:blip r:embed="rId7"/>
            <a:stretch/>
          </p:blipFill>
          <p:spPr>
            <a:xfrm>
              <a:off x="5662440" y="2058480"/>
              <a:ext cx="1098720" cy="104148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49" name="Picture 5" descr=""/>
            <p:cNvPicPr/>
            <p:nvPr/>
          </p:nvPicPr>
          <p:blipFill>
            <a:blip r:embed="rId8"/>
            <a:stretch/>
          </p:blipFill>
          <p:spPr>
            <a:xfrm>
              <a:off x="4543920" y="3120840"/>
              <a:ext cx="1098720" cy="104148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50" name="TextBox 29"/>
            <p:cNvSpPr/>
            <p:nvPr/>
          </p:nvSpPr>
          <p:spPr>
            <a:xfrm>
              <a:off x="4551480" y="2061000"/>
              <a:ext cx="5248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ffffff"/>
                  </a:solidFill>
                  <a:latin typeface="Calibri"/>
                  <a:ea typeface="Malgun Gothic"/>
                </a:rPr>
                <a:t>DAPI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1" name="TextBox 30"/>
            <p:cNvSpPr/>
            <p:nvPr/>
          </p:nvSpPr>
          <p:spPr>
            <a:xfrm>
              <a:off x="5669280" y="2061000"/>
              <a:ext cx="5259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ffffff"/>
                  </a:solidFill>
                  <a:latin typeface="Calibri"/>
                  <a:ea typeface="Malgun Gothic"/>
                </a:rPr>
                <a:t>Iba-1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2" name="TextBox 31"/>
            <p:cNvSpPr/>
            <p:nvPr/>
          </p:nvSpPr>
          <p:spPr>
            <a:xfrm>
              <a:off x="4552920" y="3125520"/>
              <a:ext cx="5248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ffffff"/>
                  </a:solidFill>
                  <a:latin typeface="Calibri"/>
                  <a:ea typeface="Malgun Gothic"/>
                </a:rPr>
                <a:t>GFAP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3" name="TextBox 32"/>
            <p:cNvSpPr/>
            <p:nvPr/>
          </p:nvSpPr>
          <p:spPr>
            <a:xfrm>
              <a:off x="5671080" y="3125520"/>
              <a:ext cx="5983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ffffff"/>
                  </a:solidFill>
                  <a:latin typeface="Calibri"/>
                  <a:ea typeface="Malgun Gothic"/>
                </a:rPr>
                <a:t>Merge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4" name="TextBox 30"/>
            <p:cNvSpPr/>
            <p:nvPr/>
          </p:nvSpPr>
          <p:spPr>
            <a:xfrm>
              <a:off x="2304360" y="2065680"/>
              <a:ext cx="5248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ffffff"/>
                  </a:solidFill>
                  <a:latin typeface="Calibri"/>
                  <a:ea typeface="Malgun Gothic"/>
                </a:rPr>
                <a:t>DAPI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5" name="TextBox 31"/>
            <p:cNvSpPr/>
            <p:nvPr/>
          </p:nvSpPr>
          <p:spPr>
            <a:xfrm>
              <a:off x="3422520" y="2065680"/>
              <a:ext cx="5248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ffffff"/>
                  </a:solidFill>
                  <a:latin typeface="Calibri"/>
                  <a:ea typeface="Malgun Gothic"/>
                </a:rPr>
                <a:t>Iba-1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6" name="TextBox 32"/>
            <p:cNvSpPr/>
            <p:nvPr/>
          </p:nvSpPr>
          <p:spPr>
            <a:xfrm>
              <a:off x="2304360" y="3129120"/>
              <a:ext cx="5248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ffffff"/>
                  </a:solidFill>
                  <a:latin typeface="Calibri"/>
                  <a:ea typeface="Malgun Gothic"/>
                </a:rPr>
                <a:t>O4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7" name="TextBox 33"/>
            <p:cNvSpPr/>
            <p:nvPr/>
          </p:nvSpPr>
          <p:spPr>
            <a:xfrm>
              <a:off x="3422520" y="3129120"/>
              <a:ext cx="6278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ffffff"/>
                  </a:solidFill>
                  <a:latin typeface="Calibri"/>
                  <a:ea typeface="Malgun Gothic"/>
                </a:rPr>
                <a:t>Merge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8" name="TextBox 34"/>
            <p:cNvSpPr/>
            <p:nvPr/>
          </p:nvSpPr>
          <p:spPr>
            <a:xfrm>
              <a:off x="2304360" y="2862720"/>
              <a:ext cx="5248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ffffff"/>
                  </a:solidFill>
                  <a:latin typeface="Calibri"/>
                  <a:ea typeface="Malgun Gothic"/>
                </a:rPr>
                <a:t>10x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9" name="TextBox 34"/>
            <p:cNvSpPr/>
            <p:nvPr/>
          </p:nvSpPr>
          <p:spPr>
            <a:xfrm>
              <a:off x="4551480" y="2858400"/>
              <a:ext cx="5248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ffffff"/>
                  </a:solidFill>
                  <a:latin typeface="Calibri"/>
                  <a:ea typeface="Malgun Gothic"/>
                </a:rPr>
                <a:t>10x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60" name="TextBox 25"/>
          <p:cNvSpPr/>
          <p:nvPr/>
        </p:nvSpPr>
        <p:spPr>
          <a:xfrm>
            <a:off x="123840" y="4533840"/>
            <a:ext cx="6637320" cy="641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  <a:ea typeface="Gulim"/>
              </a:rPr>
              <a:t>Figure S1. Purity of microglia cells in culture assessed by immunofluorescence detection of Iba-1- (microglia marker, red), GFAP- (astrocyte marker, green) or O4-positive cells (oligodendrocyte marker, green). The purity of the Iba-1-positive microglia was &gt;90%. 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graphicFrame>
        <p:nvGraphicFramePr>
          <p:cNvPr id="61" name="Object 1"/>
          <p:cNvGraphicFramePr/>
          <p:nvPr/>
        </p:nvGraphicFramePr>
        <p:xfrm>
          <a:off x="49320" y="2327400"/>
          <a:ext cx="2182680" cy="1823760"/>
        </p:xfrm>
        <a:graphic>
          <a:graphicData uri="http://schemas.openxmlformats.org/presentationml/2006/ole">
            <p:oleObj r:id="rId9" spid="">
              <p:embed/>
              <p:pic>
                <p:nvPicPr>
                  <p:cNvPr id="62" name="Object 1" descr=""/>
                  <p:cNvPicPr/>
                  <p:nvPr/>
                </p:nvPicPr>
                <p:blipFill>
                  <a:blip r:embed="rId10"/>
                  <a:stretch/>
                </p:blipFill>
                <p:spPr>
                  <a:xfrm>
                    <a:off x="49320" y="2327400"/>
                    <a:ext cx="2182680" cy="182376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3" name="TextBox 3"/>
          <p:cNvSpPr/>
          <p:nvPr/>
        </p:nvSpPr>
        <p:spPr>
          <a:xfrm>
            <a:off x="260280" y="4533840"/>
            <a:ext cx="6388200" cy="824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  <a:ea typeface="Gulim"/>
              </a:rPr>
              <a:t>Figure S2. Dose- and time-dependent effect of LPS on TNF-</a:t>
            </a:r>
            <a:r>
              <a:rPr b="0" lang="el-GR" sz="1200" spc="-1" strike="noStrike">
                <a:solidFill>
                  <a:srgbClr val="000000"/>
                </a:solidFill>
                <a:latin typeface="Calibri"/>
                <a:ea typeface="Malgun Gothic"/>
              </a:rPr>
              <a:t>α</a:t>
            </a:r>
            <a:r>
              <a:rPr b="0" lang="en-US" sz="1200" spc="-1" strike="noStrike">
                <a:solidFill>
                  <a:srgbClr val="000000"/>
                </a:solidFill>
                <a:latin typeface="Calibri"/>
                <a:ea typeface="Gulim"/>
              </a:rPr>
              <a:t> expression in BV2 murine microglia cells. Cells were incubated with LPS (ng/mL) at indicated concentration for 30 min, 1 h, and 4 h. Data are presented as mean ± SEM (n=3). The statistical significance was evaluated by Student </a:t>
            </a:r>
            <a:r>
              <a:rPr b="0" i="1" lang="en-US" sz="1200" spc="-1" strike="noStrike">
                <a:solidFill>
                  <a:srgbClr val="000000"/>
                </a:solidFill>
                <a:latin typeface="Calibri"/>
                <a:ea typeface="Gulim"/>
              </a:rPr>
              <a:t>t</a:t>
            </a:r>
            <a:r>
              <a:rPr b="0" lang="en-US" sz="1200" spc="-1" strike="noStrike">
                <a:solidFill>
                  <a:srgbClr val="000000"/>
                </a:solidFill>
                <a:latin typeface="Calibri"/>
                <a:ea typeface="Gulim"/>
              </a:rPr>
              <a:t>-test compared with control (CTL). 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graphicFrame>
        <p:nvGraphicFramePr>
          <p:cNvPr id="64" name="Object 2"/>
          <p:cNvGraphicFramePr/>
          <p:nvPr/>
        </p:nvGraphicFramePr>
        <p:xfrm>
          <a:off x="911160" y="1087560"/>
          <a:ext cx="5019840" cy="3446280"/>
        </p:xfrm>
        <a:graphic>
          <a:graphicData uri="http://schemas.openxmlformats.org/presentationml/2006/ole">
            <p:oleObj r:id="rId1" spid="">
              <p:embed/>
              <p:pic>
                <p:nvPicPr>
                  <p:cNvPr id="65" name="Object 2" descr=""/>
                  <p:cNvPicPr/>
                  <p:nvPr/>
                </p:nvPicPr>
                <p:blipFill>
                  <a:blip r:embed="rId2"/>
                  <a:stretch/>
                </p:blipFill>
                <p:spPr>
                  <a:xfrm>
                    <a:off x="911160" y="1087560"/>
                    <a:ext cx="5019840" cy="344628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6" name="TextBox 25"/>
          <p:cNvSpPr/>
          <p:nvPr/>
        </p:nvSpPr>
        <p:spPr>
          <a:xfrm>
            <a:off x="123840" y="4533840"/>
            <a:ext cx="6637320" cy="1189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  <a:ea typeface="Gulim"/>
              </a:rPr>
              <a:t>Figure S3. Effect of synaptamide on the plasma pro-inflammatory cytokines production in LPS-challenged mice. </a:t>
            </a:r>
            <a:r>
              <a:rPr b="0" lang="en-US" sz="1200" spc="-1" strike="noStrike">
                <a:solidFill>
                  <a:srgbClr val="000000"/>
                </a:solidFill>
                <a:latin typeface="Calibri"/>
                <a:ea typeface="Malgun Gothic"/>
              </a:rPr>
              <a:t>C57BL/6 mice (n=3 for each group) were treated with LPS (1 mg/kg, i.p.) followed by synaptamide (5 mg/kg, i.p.), and blood was collect at 2 and 6 h. Cytokine levels in the plasma were determine by ELISA.  Data are presented as mean ± SEM. </a:t>
            </a:r>
            <a:r>
              <a:rPr b="0" lang="en-US" sz="1200" spc="-1" strike="noStrike">
                <a:solidFill>
                  <a:srgbClr val="000000"/>
                </a:solidFill>
                <a:latin typeface="Calibri"/>
                <a:ea typeface="Gulim"/>
              </a:rPr>
              <a:t>The statistical significance was evaluated by Student </a:t>
            </a:r>
            <a:r>
              <a:rPr b="0" i="1" lang="en-US" sz="1200" spc="-1" strike="noStrike">
                <a:solidFill>
                  <a:srgbClr val="000000"/>
                </a:solidFill>
                <a:latin typeface="Calibri"/>
                <a:ea typeface="Gulim"/>
              </a:rPr>
              <a:t>t</a:t>
            </a:r>
            <a:r>
              <a:rPr b="0" lang="en-US" sz="1200" spc="-1" strike="noStrike">
                <a:solidFill>
                  <a:srgbClr val="000000"/>
                </a:solidFill>
                <a:latin typeface="Calibri"/>
                <a:ea typeface="Gulim"/>
              </a:rPr>
              <a:t>-test compared with the LPS-treatment. 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graphicFrame>
        <p:nvGraphicFramePr>
          <p:cNvPr id="67" name="Object 5"/>
          <p:cNvGraphicFramePr/>
          <p:nvPr/>
        </p:nvGraphicFramePr>
        <p:xfrm>
          <a:off x="0" y="1782720"/>
          <a:ext cx="3154320" cy="2583000"/>
        </p:xfrm>
        <a:graphic>
          <a:graphicData uri="http://schemas.openxmlformats.org/presentationml/2006/ole">
            <p:oleObj r:id="rId1" spid="">
              <p:embed/>
              <p:pic>
                <p:nvPicPr>
                  <p:cNvPr id="68" name="Object 5" descr=""/>
                  <p:cNvPicPr/>
                  <p:nvPr/>
                </p:nvPicPr>
                <p:blipFill>
                  <a:blip r:embed="rId2"/>
                  <a:stretch/>
                </p:blipFill>
                <p:spPr>
                  <a:xfrm>
                    <a:off x="0" y="1782720"/>
                    <a:ext cx="3154320" cy="258300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aphicFrame>
        <p:nvGraphicFramePr>
          <p:cNvPr id="69" name="Object 6"/>
          <p:cNvGraphicFramePr/>
          <p:nvPr/>
        </p:nvGraphicFramePr>
        <p:xfrm>
          <a:off x="3443400" y="1782720"/>
          <a:ext cx="3152520" cy="2583000"/>
        </p:xfrm>
        <a:graphic>
          <a:graphicData uri="http://schemas.openxmlformats.org/presentationml/2006/ole">
            <p:oleObj r:id="rId3" spid="">
              <p:embed/>
              <p:pic>
                <p:nvPicPr>
                  <p:cNvPr id="70" name="Object 6" descr=""/>
                  <p:cNvPicPr/>
                  <p:nvPr/>
                </p:nvPicPr>
                <p:blipFill>
                  <a:blip r:embed="rId4"/>
                  <a:stretch/>
                </p:blipFill>
                <p:spPr>
                  <a:xfrm>
                    <a:off x="3443400" y="1782720"/>
                    <a:ext cx="3152520" cy="258300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1" name="TextBox 25"/>
          <p:cNvSpPr/>
          <p:nvPr/>
        </p:nvSpPr>
        <p:spPr>
          <a:xfrm>
            <a:off x="220680" y="6060960"/>
            <a:ext cx="6637320" cy="1189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  <a:ea typeface="Gulim"/>
              </a:rPr>
              <a:t>Figure S4. </a:t>
            </a: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Suppression of LPS-induced IL-1</a:t>
            </a:r>
            <a:r>
              <a:rPr b="0" lang="el-GR" sz="1200" spc="-1" strike="noStrike">
                <a:solidFill>
                  <a:srgbClr val="000000"/>
                </a:solidFill>
                <a:latin typeface="Calibri"/>
              </a:rPr>
              <a:t>β</a:t>
            </a: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, IL-6, and CCL2 expression specifically by synaptamide</a:t>
            </a:r>
            <a:r>
              <a:rPr b="0" lang="en-US" sz="1200" spc="-1" strike="noStrike">
                <a:solidFill>
                  <a:srgbClr val="000000"/>
                </a:solidFill>
                <a:latin typeface="Calibri"/>
                <a:ea typeface="Gulim"/>
              </a:rPr>
              <a:t>.  BV2 </a:t>
            </a: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cells were treated with LPS (100 ng/mL) and 10 nM fatty acyl ethanolamides were added immediately after the LPS exposure.  Levels of IL-1</a:t>
            </a:r>
            <a:r>
              <a:rPr b="0" lang="el-GR" sz="1200" spc="-1" strike="noStrike">
                <a:solidFill>
                  <a:srgbClr val="000000"/>
                </a:solidFill>
                <a:latin typeface="Calibri"/>
              </a:rPr>
              <a:t>β</a:t>
            </a: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, IL-6, and CCL2 mRNA were determined by qPCR after 1 h incubation. The data represent the mean ± SEM of three independent experiments. </a:t>
            </a:r>
            <a:r>
              <a:rPr b="0" lang="en-US" sz="1200" spc="-1" strike="noStrike">
                <a:solidFill>
                  <a:srgbClr val="000000"/>
                </a:solidFill>
                <a:latin typeface="Calibri"/>
                <a:ea typeface="Gulim"/>
              </a:rPr>
              <a:t>The statistical significance was evaluated by Student </a:t>
            </a:r>
            <a:r>
              <a:rPr b="0" i="1" lang="en-US" sz="1200" spc="-1" strike="noStrike">
                <a:solidFill>
                  <a:srgbClr val="000000"/>
                </a:solidFill>
                <a:latin typeface="Calibri"/>
                <a:ea typeface="Gulim"/>
              </a:rPr>
              <a:t>t</a:t>
            </a:r>
            <a:r>
              <a:rPr b="0" lang="en-US" sz="1200" spc="-1" strike="noStrike">
                <a:solidFill>
                  <a:srgbClr val="000000"/>
                </a:solidFill>
                <a:latin typeface="Calibri"/>
                <a:ea typeface="Gulim"/>
              </a:rPr>
              <a:t>-test compared with the LPS-treatment. 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graphicFrame>
        <p:nvGraphicFramePr>
          <p:cNvPr id="72" name="Object 4"/>
          <p:cNvGraphicFramePr/>
          <p:nvPr/>
        </p:nvGraphicFramePr>
        <p:xfrm>
          <a:off x="14400" y="717480"/>
          <a:ext cx="3200400" cy="2390760"/>
        </p:xfrm>
        <a:graphic>
          <a:graphicData uri="http://schemas.openxmlformats.org/presentationml/2006/ole">
            <p:oleObj r:id="rId1" spid="">
              <p:embed/>
              <p:pic>
                <p:nvPicPr>
                  <p:cNvPr id="73" name="Object 4" descr=""/>
                  <p:cNvPicPr/>
                  <p:nvPr/>
                </p:nvPicPr>
                <p:blipFill>
                  <a:blip r:embed="rId2"/>
                  <a:stretch/>
                </p:blipFill>
                <p:spPr>
                  <a:xfrm>
                    <a:off x="14400" y="717480"/>
                    <a:ext cx="3200400" cy="239076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aphicFrame>
        <p:nvGraphicFramePr>
          <p:cNvPr id="74" name="Object 5"/>
          <p:cNvGraphicFramePr/>
          <p:nvPr/>
        </p:nvGraphicFramePr>
        <p:xfrm>
          <a:off x="3398760" y="717480"/>
          <a:ext cx="3200400" cy="2390760"/>
        </p:xfrm>
        <a:graphic>
          <a:graphicData uri="http://schemas.openxmlformats.org/presentationml/2006/ole">
            <p:oleObj r:id="rId3" spid="">
              <p:embed/>
              <p:pic>
                <p:nvPicPr>
                  <p:cNvPr id="75" name="Object 5" descr=""/>
                  <p:cNvPicPr/>
                  <p:nvPr/>
                </p:nvPicPr>
                <p:blipFill>
                  <a:blip r:embed="rId4"/>
                  <a:stretch/>
                </p:blipFill>
                <p:spPr>
                  <a:xfrm>
                    <a:off x="3398760" y="717480"/>
                    <a:ext cx="3200400" cy="239076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aphicFrame>
        <p:nvGraphicFramePr>
          <p:cNvPr id="76" name="Object 6"/>
          <p:cNvGraphicFramePr/>
          <p:nvPr/>
        </p:nvGraphicFramePr>
        <p:xfrm>
          <a:off x="14400" y="3108240"/>
          <a:ext cx="3200400" cy="2389320"/>
        </p:xfrm>
        <a:graphic>
          <a:graphicData uri="http://schemas.openxmlformats.org/presentationml/2006/ole">
            <p:oleObj r:id="rId5" spid="">
              <p:embed/>
              <p:pic>
                <p:nvPicPr>
                  <p:cNvPr id="77" name="Object 6" descr=""/>
                  <p:cNvPicPr/>
                  <p:nvPr/>
                </p:nvPicPr>
                <p:blipFill>
                  <a:blip r:embed="rId6"/>
                  <a:stretch/>
                </p:blipFill>
                <p:spPr>
                  <a:xfrm>
                    <a:off x="14400" y="3108240"/>
                    <a:ext cx="3200400" cy="238932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258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6-07-22T15:41:09Z</dcterms:created>
  <dc:creator>Park, Taeyeop (NIH/NIAAA) [F]</dc:creator>
  <dc:description/>
  <dc:language>en-US</dc:language>
  <cp:lastModifiedBy>wdesales</cp:lastModifiedBy>
  <cp:lastPrinted>2016-10-03T12:15:43Z</cp:lastPrinted>
  <dcterms:modified xsi:type="dcterms:W3CDTF">2016-10-26T01:09:37Z</dcterms:modified>
  <cp:revision>120</cp:revision>
  <dc:subject/>
  <dc:title>PowerPoint Presentation</dc:title>
</cp:coreProperties>
</file>